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77" r:id="rId3"/>
    <p:sldId id="278" r:id="rId4"/>
    <p:sldId id="276" r:id="rId5"/>
    <p:sldId id="274" r:id="rId6"/>
    <p:sldId id="275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454" autoAdjust="0"/>
  </p:normalViewPr>
  <p:slideViewPr>
    <p:cSldViewPr snapToGrid="0">
      <p:cViewPr>
        <p:scale>
          <a:sx n="51" d="100"/>
          <a:sy n="51" d="100"/>
        </p:scale>
        <p:origin x="1232" y="4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66EBCD-F6D4-4F2A-854C-FF0986FC37AA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3EC19B-B79E-4055-8C31-72815C9EE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36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Figure S13. Correlation matrix </a:t>
            </a:r>
            <a:r>
              <a:rPr lang="en-US" dirty="0" err="1" smtClean="0"/>
              <a:t>heatmaps</a:t>
            </a:r>
            <a:r>
              <a:rPr lang="en-US" dirty="0" smtClean="0"/>
              <a:t> with Kendall’s tau values. MS: male saline, MT: male Thiamet G, FS: female saline, FT: female Thiamet G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3EC19B-B79E-4055-8C31-72815C9EE82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3206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dirty="0"/>
              <a:t>Figure S14. Scatter plots with regression lines for OGA activity and LAMP1 relationship. Kendall’s correlation coefficients and p-values are shown. Fs: female saline, ft: female Thiamet G, </a:t>
            </a:r>
            <a:r>
              <a:rPr lang="en-US" dirty="0" err="1"/>
              <a:t>ms</a:t>
            </a:r>
            <a:r>
              <a:rPr lang="en-US" dirty="0"/>
              <a:t>: male saline, mt: male Thiamet </a:t>
            </a:r>
            <a:r>
              <a:rPr lang="en-US" dirty="0" smtClean="0"/>
              <a:t>G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3EC19B-B79E-4055-8C31-72815C9EE82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98517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dirty="0"/>
              <a:t>Figure S15. Scatter plots with regression lines for OGA activity and LC3I relationship. Kendall’s correlation coefficients and p-values are shown. Fs: female saline, ft: female Thiamet G, </a:t>
            </a:r>
            <a:r>
              <a:rPr lang="en-US" dirty="0" err="1"/>
              <a:t>ms</a:t>
            </a:r>
            <a:r>
              <a:rPr lang="en-US" dirty="0"/>
              <a:t>: male saline, mt: male Thiamet </a:t>
            </a:r>
            <a:r>
              <a:rPr lang="en-US" dirty="0" smtClean="0"/>
              <a:t>G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3EC19B-B79E-4055-8C31-72815C9EE82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4365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dirty="0"/>
              <a:t>Figure </a:t>
            </a:r>
            <a:r>
              <a:rPr lang="en-US" dirty="0" smtClean="0"/>
              <a:t>S16. </a:t>
            </a:r>
            <a:r>
              <a:rPr lang="en-US" dirty="0"/>
              <a:t>Scatter plots with regression lines for O-</a:t>
            </a:r>
            <a:r>
              <a:rPr lang="en-US" dirty="0" err="1"/>
              <a:t>GlcNAc</a:t>
            </a:r>
            <a:r>
              <a:rPr lang="en-US" dirty="0"/>
              <a:t> level and LC3I relationship. Kendall’s correlation coefficients and p-values are shown. Fs: female saline, ft: female Thiamet G, </a:t>
            </a:r>
            <a:r>
              <a:rPr lang="en-US" dirty="0" err="1"/>
              <a:t>ms</a:t>
            </a:r>
            <a:r>
              <a:rPr lang="en-US" dirty="0"/>
              <a:t>: male saline, mt: male Thiamet </a:t>
            </a:r>
            <a:r>
              <a:rPr lang="en-US" dirty="0" smtClean="0"/>
              <a:t>G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3EC19B-B79E-4055-8C31-72815C9EE82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55379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dirty="0"/>
              <a:t>Figure </a:t>
            </a:r>
            <a:r>
              <a:rPr lang="en-US" dirty="0" smtClean="0"/>
              <a:t>S17. </a:t>
            </a:r>
            <a:r>
              <a:rPr lang="en-US" dirty="0"/>
              <a:t>Scatter plots with regression lines for LC3II and complex I (C_I) relationship. Kendall’s correlation coefficients and p-values are shown. Fs: female saline, ft: female Thiamet G, </a:t>
            </a:r>
            <a:r>
              <a:rPr lang="en-US" dirty="0" err="1"/>
              <a:t>ms</a:t>
            </a:r>
            <a:r>
              <a:rPr lang="en-US" dirty="0"/>
              <a:t>: male saline, mt: male Thiamet </a:t>
            </a:r>
            <a:r>
              <a:rPr lang="en-US" dirty="0" smtClean="0"/>
              <a:t>G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3EC19B-B79E-4055-8C31-72815C9EE82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95596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dirty="0"/>
              <a:t>Figure </a:t>
            </a:r>
            <a:r>
              <a:rPr lang="en-US" dirty="0" smtClean="0"/>
              <a:t>S18. </a:t>
            </a:r>
            <a:r>
              <a:rPr lang="en-US" dirty="0"/>
              <a:t>Scatter plots with regression lines for PICALM and complex III (C_III) relationship. Kendall’s correlation coefficients and p-values are shown. Fs: female saline, ft: female Thiamet G, </a:t>
            </a:r>
            <a:r>
              <a:rPr lang="en-US" dirty="0" err="1"/>
              <a:t>ms</a:t>
            </a:r>
            <a:r>
              <a:rPr lang="en-US" dirty="0"/>
              <a:t>: male saline, mt: male Thiamet </a:t>
            </a:r>
            <a:r>
              <a:rPr lang="en-US" dirty="0" smtClean="0"/>
              <a:t>G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3EC19B-B79E-4055-8C31-72815C9EE82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2789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94962E-A3D7-416D-8ECF-15C5110543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D2B4E51-CB25-446F-8713-EF132E5B75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511CFD-80B1-4AFF-A56E-207C5FA55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076213-630A-4831-812D-2D6109383E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36E4E4-B82B-4DF0-ABB5-7A3CCB7EDE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865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3A0F61-4927-463B-9405-F714F93C49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5CD499-9185-4B22-802C-ED3D3E00BE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FD6984-5485-497B-A2FD-10788D236A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9F1B62-9D58-4E9D-A7A1-441308705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01C7DC-44DE-46B6-ACB2-B7B70005F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978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6FC2D7-7271-437D-BD54-5F6210177C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38A445-9C94-44A0-9FD4-1A43807F6F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0E9D56-FB00-47AD-ACDE-7F28757F4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2B4F13-5661-4F77-899E-0CBA58F46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7D4DFB-63AE-42B6-8042-46E170254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424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A1A895-5B85-46BF-8582-E33361F70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E887F5-5328-43A3-94F2-3885E07254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433A8D-9039-44CA-8908-063B4622C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604A08-FCCD-42F5-8EF7-F40C5695CB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5B5061-AE73-4656-80D6-893301B864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262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53363-EC45-4E18-9039-26247B14AC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095B0D-439E-42FA-BE98-1256C04F7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BB5368-760F-4065-B523-67A6FCD1B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461451-E882-408C-81FB-35B5A24A9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8C50E-EE5C-4BBA-BC3A-F4244BBE6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159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9661EF-FF82-426F-93E1-7717F1AFB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601A13-C5FD-4BC3-B839-4FB1005630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C1B338-85C8-4E97-A64E-CF442A03C0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A1F68B-1370-48C8-85FC-03C06D648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C32B6F-A5AB-4F61-BC99-9B56C1992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0D9E3C-B594-4D0E-8692-34CFF54B7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948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5B3711-7F32-4C50-81DE-DD6C913D5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C170ED-97E4-428A-87FF-58843B92AE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DB43CE-4277-4286-A334-C85A93CE30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118CEF-AF08-4C2A-AF67-F4BC4C3538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ACD887-B740-4361-9AC1-E34DA10768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A6AEFF-61EF-4177-9085-7017959AF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91AB8F-B73C-41CD-9B5C-A7D43B447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FE64B4-5547-47A1-8E94-539A964F95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907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B6957-AAA5-4A96-9453-D915B3A26D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3A7073A-E4FD-4937-AF1F-5F6A45E44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403C61E-C97F-45DE-8A9D-E782951B1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CC6AB1-0866-4DA2-B00A-56395DFAA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452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E2CF26-2D46-4B72-B620-AE2886FBA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17248F-9085-4163-877B-7C136E720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B900C7-F73F-452C-9D24-C9688ACA8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68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B152B4-1ED3-4F08-83F8-A40EB97EB6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9AC2C6-4A96-4D5C-895A-9D966464C6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F0884C-E355-4B0A-94AC-EF8E291FF0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B584EE-C074-404A-A92E-4E617420D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7B5560-C1B6-4DC5-A495-513E8DA7F5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A23B71-7953-4FED-81E7-C098B29BEE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68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1818D0-2FF7-4255-807F-98010BC27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BC7389-73F4-46CB-9C4A-E3FD6CDE04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D12E75-4531-461C-8987-E583203DC4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35CF4F-8F38-4990-93E5-73E8E37AE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E3F796-A00B-439B-B026-7D9225848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D8E119-7B02-4BED-9A02-43B8D6617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9659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A48D7F-0F13-4321-AA98-E141D5720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CA13D9-415D-43EF-AB45-C044CB0F20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3A1A5F-BA08-4799-B682-19E848A3EF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90160-ABD8-4469-A032-1A6EF775714B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ED92A7-E4C9-4A15-9AE7-56A435A22B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C8FBD8-A897-4F32-B96F-8F22CF5DF4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B2033-85AE-434D-BB2E-06FEC1138D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33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954C5722-66FC-47E7-B98B-CBD69AC89D47}"/>
              </a:ext>
            </a:extLst>
          </p:cNvPr>
          <p:cNvGrpSpPr/>
          <p:nvPr/>
        </p:nvGrpSpPr>
        <p:grpSpPr>
          <a:xfrm>
            <a:off x="1634082" y="199531"/>
            <a:ext cx="8323335" cy="6909006"/>
            <a:chOff x="1805378" y="257908"/>
            <a:chExt cx="8323335" cy="690900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F26266A-600D-47D2-B99F-1A88EBB1D1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102" b="-10102"/>
            <a:stretch/>
          </p:blipFill>
          <p:spPr>
            <a:xfrm>
              <a:off x="6096000" y="3528323"/>
              <a:ext cx="4032713" cy="363859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C7177DA-2938-4D2E-BAAE-CB1B4D5E09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206"/>
            <a:stretch/>
          </p:blipFill>
          <p:spPr>
            <a:xfrm>
              <a:off x="1805378" y="3532094"/>
              <a:ext cx="4032713" cy="326726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3E01F48-9CD2-4CB9-A409-F9DADFEF7D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896"/>
            <a:stretch/>
          </p:blipFill>
          <p:spPr>
            <a:xfrm>
              <a:off x="6096000" y="286871"/>
              <a:ext cx="4031627" cy="3241274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AEBE764-C3EE-45AA-A6BD-687BE796A7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893"/>
            <a:stretch/>
          </p:blipFill>
          <p:spPr>
            <a:xfrm>
              <a:off x="1805378" y="286871"/>
              <a:ext cx="4032713" cy="3242254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F81267F-AA05-414D-BBA3-743F463B9F9C}"/>
                </a:ext>
              </a:extLst>
            </p:cNvPr>
            <p:cNvSpPr txBox="1"/>
            <p:nvPr/>
          </p:nvSpPr>
          <p:spPr>
            <a:xfrm>
              <a:off x="1805379" y="257908"/>
              <a:ext cx="6486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M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32B2C2F-6B25-42CE-B80B-B810F081F518}"/>
                </a:ext>
              </a:extLst>
            </p:cNvPr>
            <p:cNvSpPr txBox="1"/>
            <p:nvPr/>
          </p:nvSpPr>
          <p:spPr>
            <a:xfrm>
              <a:off x="6170272" y="257908"/>
              <a:ext cx="6486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M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974C567-A8E8-4F7F-BC13-37779591B8CB}"/>
                </a:ext>
              </a:extLst>
            </p:cNvPr>
            <p:cNvSpPr txBox="1"/>
            <p:nvPr/>
          </p:nvSpPr>
          <p:spPr>
            <a:xfrm>
              <a:off x="1805379" y="3645878"/>
              <a:ext cx="6486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F73F96C-1B73-4AED-952A-DE4886E37B90}"/>
                </a:ext>
              </a:extLst>
            </p:cNvPr>
            <p:cNvSpPr txBox="1"/>
            <p:nvPr/>
          </p:nvSpPr>
          <p:spPr>
            <a:xfrm>
              <a:off x="6170272" y="3645878"/>
              <a:ext cx="6486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T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130959" y="45643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S1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99258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42E3BFB4-6E26-46DC-9013-D24A9F38741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35" r="894"/>
          <a:stretch/>
        </p:blipFill>
        <p:spPr>
          <a:xfrm>
            <a:off x="914400" y="0"/>
            <a:ext cx="10346500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0959" y="45643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4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82022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7D34B16-EC83-45EF-9912-9387C2DEB4F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6" r="537"/>
          <a:stretch/>
        </p:blipFill>
        <p:spPr>
          <a:xfrm>
            <a:off x="1068886" y="45643"/>
            <a:ext cx="10396604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0959" y="45643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5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4745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B76A55-EC8D-411B-AA2E-F305E61A9F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F9AFF9-AD9D-44FC-8CDB-3B46F4BA10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82C7929-27DE-450F-A5E3-715D42AEFB3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74" r="655"/>
          <a:stretch/>
        </p:blipFill>
        <p:spPr>
          <a:xfrm>
            <a:off x="939452" y="0"/>
            <a:ext cx="10346500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0959" y="45643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6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58243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72712-2789-4436-B530-17D8455576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9F896E-EF4C-4CA4-97A4-CAD8198624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6232791-13C1-4F83-A638-A515695A05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35" r="419"/>
          <a:stretch/>
        </p:blipFill>
        <p:spPr>
          <a:xfrm>
            <a:off x="914400" y="0"/>
            <a:ext cx="10396604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0959" y="45643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7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41548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1FC830-6EB9-40FC-8FA5-138C460B3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A4B641-898E-47AA-BDCB-152DCE8C40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F02E912-5641-4298-8205-C478DB4C1F1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74" r="418"/>
          <a:stretch/>
        </p:blipFill>
        <p:spPr>
          <a:xfrm>
            <a:off x="939452" y="0"/>
            <a:ext cx="10371552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0959" y="45643"/>
            <a:ext cx="23230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8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7271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292</Words>
  <Application>Microsoft Office PowerPoint</Application>
  <PresentationFormat>Widescreen</PresentationFormat>
  <Paragraphs>22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n Huynh</dc:creator>
  <cp:lastModifiedBy>Zhang, Jianhua (Campus)</cp:lastModifiedBy>
  <cp:revision>22</cp:revision>
  <dcterms:created xsi:type="dcterms:W3CDTF">2021-12-21T02:34:42Z</dcterms:created>
  <dcterms:modified xsi:type="dcterms:W3CDTF">2021-12-22T19:29:59Z</dcterms:modified>
</cp:coreProperties>
</file>